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0" d="100"/>
          <a:sy n="100" d="100"/>
        </p:scale>
        <p:origin x="-102" y="-180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82572-34FA-4363-96F3-EC733A20E8C3}" type="datetimeFigureOut">
              <a:rPr lang="en-US" smtClean="0"/>
              <a:t>11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90255-C85A-48DD-B163-C38D5876D9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27969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82572-34FA-4363-96F3-EC733A20E8C3}" type="datetimeFigureOut">
              <a:rPr lang="en-US" smtClean="0"/>
              <a:t>11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90255-C85A-48DD-B163-C38D5876D9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14976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780337" y="274639"/>
            <a:ext cx="2414588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6575" y="274639"/>
            <a:ext cx="7078663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82572-34FA-4363-96F3-EC733A20E8C3}" type="datetimeFigureOut">
              <a:rPr lang="en-US" smtClean="0"/>
              <a:t>11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90255-C85A-48DD-B163-C38D5876D9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57447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82572-34FA-4363-96F3-EC733A20E8C3}" type="datetimeFigureOut">
              <a:rPr lang="en-US" smtClean="0"/>
              <a:t>11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90255-C85A-48DD-B163-C38D5876D9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87529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82572-34FA-4363-96F3-EC733A20E8C3}" type="datetimeFigureOut">
              <a:rPr lang="en-US" smtClean="0"/>
              <a:t>11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90255-C85A-48DD-B163-C38D5876D9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12708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6575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48300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82572-34FA-4363-96F3-EC733A20E8C3}" type="datetimeFigureOut">
              <a:rPr lang="en-US" smtClean="0"/>
              <a:t>11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90255-C85A-48DD-B163-C38D5876D9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76110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82572-34FA-4363-96F3-EC733A20E8C3}" type="datetimeFigureOut">
              <a:rPr lang="en-US" smtClean="0"/>
              <a:t>11/5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90255-C85A-48DD-B163-C38D5876D9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29293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82572-34FA-4363-96F3-EC733A20E8C3}" type="datetimeFigureOut">
              <a:rPr lang="en-US" smtClean="0"/>
              <a:t>11/5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90255-C85A-48DD-B163-C38D5876D9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99030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82572-34FA-4363-96F3-EC733A20E8C3}" type="datetimeFigureOut">
              <a:rPr lang="en-US" smtClean="0"/>
              <a:t>11/5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90255-C85A-48DD-B163-C38D5876D9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81004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82572-34FA-4363-96F3-EC733A20E8C3}" type="datetimeFigureOut">
              <a:rPr lang="en-US" smtClean="0"/>
              <a:t>11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90255-C85A-48DD-B163-C38D5876D9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52482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82572-34FA-4363-96F3-EC733A20E8C3}" type="datetimeFigureOut">
              <a:rPr lang="en-US" smtClean="0"/>
              <a:t>11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90255-C85A-48DD-B163-C38D5876D9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802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082572-34FA-4363-96F3-EC733A20E8C3}" type="datetimeFigureOut">
              <a:rPr lang="en-US" smtClean="0"/>
              <a:t>11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B90255-C85A-48DD-B163-C38D5876D9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36934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70318148"/>
              </p:ext>
            </p:extLst>
          </p:nvPr>
        </p:nvGraphicFramePr>
        <p:xfrm>
          <a:off x="73548" y="1124744"/>
          <a:ext cx="9361041" cy="367792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3384376"/>
                <a:gridCol w="2016224"/>
                <a:gridCol w="2088232"/>
                <a:gridCol w="1872209"/>
              </a:tblGrid>
              <a:tr h="370840">
                <a:tc>
                  <a:txBody>
                    <a:bodyPr/>
                    <a:lstStyle/>
                    <a:p>
                      <a:endParaRPr lang="nl-NL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dirty="0" err="1" smtClean="0"/>
                        <a:t>Normal</a:t>
                      </a:r>
                      <a:r>
                        <a:rPr lang="nl-NL" dirty="0" smtClean="0"/>
                        <a:t> </a:t>
                      </a:r>
                      <a:r>
                        <a:rPr lang="nl-NL" dirty="0" err="1" smtClean="0"/>
                        <a:t>values</a:t>
                      </a:r>
                      <a:r>
                        <a:rPr lang="nl-NL" dirty="0" smtClean="0"/>
                        <a:t> </a:t>
                      </a:r>
                      <a:r>
                        <a:rPr lang="nl-NL" dirty="0" err="1" smtClean="0"/>
                        <a:t>for</a:t>
                      </a:r>
                      <a:r>
                        <a:rPr lang="nl-NL" baseline="0" dirty="0" smtClean="0"/>
                        <a:t> </a:t>
                      </a:r>
                      <a:r>
                        <a:rPr lang="nl-NL" baseline="0" dirty="0" err="1" smtClean="0"/>
                        <a:t>adults</a:t>
                      </a:r>
                      <a:endParaRPr lang="nl-NL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dirty="0" err="1" smtClean="0"/>
                        <a:t>Normal</a:t>
                      </a:r>
                      <a:r>
                        <a:rPr lang="nl-NL" dirty="0" smtClean="0"/>
                        <a:t> </a:t>
                      </a:r>
                      <a:r>
                        <a:rPr lang="nl-NL" dirty="0" err="1" smtClean="0"/>
                        <a:t>values</a:t>
                      </a:r>
                      <a:r>
                        <a:rPr lang="nl-NL" dirty="0" smtClean="0"/>
                        <a:t> </a:t>
                      </a:r>
                      <a:r>
                        <a:rPr lang="nl-NL" dirty="0" err="1" smtClean="0"/>
                        <a:t>for</a:t>
                      </a:r>
                      <a:r>
                        <a:rPr lang="nl-NL" dirty="0" smtClean="0"/>
                        <a:t> </a:t>
                      </a:r>
                      <a:r>
                        <a:rPr lang="nl-NL" dirty="0" err="1" smtClean="0"/>
                        <a:t>children</a:t>
                      </a:r>
                      <a:r>
                        <a:rPr lang="nl-NL" baseline="0" dirty="0" smtClean="0"/>
                        <a:t> </a:t>
                      </a:r>
                      <a:r>
                        <a:rPr lang="nl-NL" baseline="0" dirty="0" err="1" smtClean="0"/>
                        <a:t>aged</a:t>
                      </a:r>
                      <a:r>
                        <a:rPr lang="nl-NL" baseline="0" dirty="0" smtClean="0"/>
                        <a:t>       10-16</a:t>
                      </a:r>
                      <a:endParaRPr lang="nl-NL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dirty="0" err="1" smtClean="0"/>
                        <a:t>Normal</a:t>
                      </a:r>
                      <a:r>
                        <a:rPr lang="nl-NL" dirty="0" smtClean="0"/>
                        <a:t> </a:t>
                      </a:r>
                      <a:r>
                        <a:rPr lang="nl-NL" dirty="0" err="1" smtClean="0"/>
                        <a:t>values</a:t>
                      </a:r>
                      <a:r>
                        <a:rPr lang="nl-NL" dirty="0" smtClean="0"/>
                        <a:t> </a:t>
                      </a:r>
                      <a:r>
                        <a:rPr lang="nl-NL" dirty="0" err="1" smtClean="0"/>
                        <a:t>for</a:t>
                      </a:r>
                      <a:r>
                        <a:rPr lang="nl-NL" dirty="0" smtClean="0"/>
                        <a:t> </a:t>
                      </a:r>
                      <a:r>
                        <a:rPr lang="nl-NL" dirty="0" err="1" smtClean="0"/>
                        <a:t>children</a:t>
                      </a:r>
                      <a:r>
                        <a:rPr lang="nl-NL" baseline="0" dirty="0" smtClean="0"/>
                        <a:t> </a:t>
                      </a:r>
                      <a:r>
                        <a:rPr lang="nl-NL" baseline="0" dirty="0" err="1" smtClean="0"/>
                        <a:t>aged</a:t>
                      </a:r>
                      <a:r>
                        <a:rPr lang="nl-NL" baseline="0" dirty="0" smtClean="0"/>
                        <a:t>      5-10</a:t>
                      </a:r>
                      <a:endParaRPr lang="nl-NL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nl-NL" dirty="0" err="1" smtClean="0"/>
                        <a:t>IgG</a:t>
                      </a:r>
                      <a:r>
                        <a:rPr lang="nl-NL" dirty="0" smtClean="0"/>
                        <a:t> (g/l)</a:t>
                      </a:r>
                      <a:endParaRPr lang="nl-NL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dirty="0" smtClean="0"/>
                        <a:t>7.0 – 16.0 </a:t>
                      </a:r>
                      <a:endParaRPr lang="nl-NL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dirty="0" smtClean="0"/>
                        <a:t>7.0 – 15.0</a:t>
                      </a:r>
                      <a:endParaRPr lang="nl-NL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dirty="0" smtClean="0"/>
                        <a:t>5.0 – 13.0</a:t>
                      </a:r>
                      <a:endParaRPr lang="nl-NL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nl-NL" dirty="0" err="1" smtClean="0"/>
                        <a:t>IgA</a:t>
                      </a:r>
                      <a:r>
                        <a:rPr lang="nl-NL" dirty="0" smtClean="0"/>
                        <a:t> (g/l)</a:t>
                      </a:r>
                      <a:endParaRPr lang="nl-NL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dirty="0" smtClean="0"/>
                        <a:t>0.76 – 3.91</a:t>
                      </a:r>
                      <a:endParaRPr lang="nl-NL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dirty="0" smtClean="0"/>
                        <a:t>0.45 – 3.95</a:t>
                      </a:r>
                      <a:endParaRPr lang="nl-NL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dirty="0" smtClean="0"/>
                        <a:t>0.50 – 2.30</a:t>
                      </a:r>
                      <a:endParaRPr lang="nl-NL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nl-NL" dirty="0" err="1" smtClean="0"/>
                        <a:t>IgM</a:t>
                      </a:r>
                      <a:r>
                        <a:rPr lang="nl-NL" dirty="0" smtClean="0"/>
                        <a:t> (g/l)</a:t>
                      </a:r>
                      <a:endParaRPr lang="nl-NL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l-NL" dirty="0" smtClean="0"/>
                        <a:t>0.45 – 2.30</a:t>
                      </a:r>
                      <a:endParaRPr lang="nl-NL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l-NL" dirty="0" smtClean="0"/>
                        <a:t>0.40 – 1.80 g</a:t>
                      </a:r>
                      <a:endParaRPr lang="nl-NL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l-NL" dirty="0" smtClean="0"/>
                        <a:t>0.30 – 1.80 </a:t>
                      </a:r>
                      <a:endParaRPr lang="nl-NL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nl-NL" dirty="0" smtClean="0"/>
                        <a:t>Total </a:t>
                      </a:r>
                      <a:r>
                        <a:rPr lang="nl-NL" dirty="0" err="1" smtClean="0"/>
                        <a:t>number</a:t>
                      </a:r>
                      <a:r>
                        <a:rPr lang="nl-NL" dirty="0" smtClean="0"/>
                        <a:t> of </a:t>
                      </a:r>
                      <a:r>
                        <a:rPr lang="nl-NL" dirty="0" err="1" smtClean="0"/>
                        <a:t>B-cells</a:t>
                      </a:r>
                      <a:r>
                        <a:rPr lang="nl-NL" dirty="0" smtClean="0"/>
                        <a:t> (x 10</a:t>
                      </a:r>
                      <a:r>
                        <a:rPr lang="nl-NL" baseline="30000" dirty="0" smtClean="0"/>
                        <a:t>9</a:t>
                      </a:r>
                      <a:r>
                        <a:rPr lang="nl-NL" dirty="0" smtClean="0"/>
                        <a:t> / l)</a:t>
                      </a:r>
                      <a:endParaRPr lang="nl-NL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l-NL" dirty="0" smtClean="0"/>
                        <a:t>0.10</a:t>
                      </a:r>
                      <a:r>
                        <a:rPr lang="nl-NL" baseline="0" dirty="0" smtClean="0"/>
                        <a:t> – 0.40</a:t>
                      </a:r>
                      <a:endParaRPr lang="nl-NL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l-NL" dirty="0" smtClean="0"/>
                        <a:t>0.20</a:t>
                      </a:r>
                      <a:r>
                        <a:rPr lang="nl-NL" baseline="0" dirty="0" smtClean="0"/>
                        <a:t> – 0.60</a:t>
                      </a:r>
                      <a:endParaRPr lang="nl-NL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l-NL" dirty="0" smtClean="0"/>
                        <a:t>0.20</a:t>
                      </a:r>
                      <a:r>
                        <a:rPr lang="nl-NL" baseline="0" dirty="0" smtClean="0"/>
                        <a:t> – 1.60</a:t>
                      </a:r>
                      <a:endParaRPr lang="nl-NL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l-NL" dirty="0" smtClean="0"/>
                        <a:t>Total </a:t>
                      </a:r>
                      <a:r>
                        <a:rPr lang="nl-NL" dirty="0" err="1" smtClean="0"/>
                        <a:t>number</a:t>
                      </a:r>
                      <a:r>
                        <a:rPr lang="nl-NL" dirty="0" smtClean="0"/>
                        <a:t> of </a:t>
                      </a:r>
                      <a:r>
                        <a:rPr lang="nl-NL" dirty="0" err="1" smtClean="0"/>
                        <a:t>T-cells</a:t>
                      </a:r>
                      <a:r>
                        <a:rPr lang="nl-NL" dirty="0" smtClean="0"/>
                        <a:t> (x 10</a:t>
                      </a:r>
                      <a:r>
                        <a:rPr lang="nl-NL" baseline="30000" dirty="0" smtClean="0"/>
                        <a:t>9</a:t>
                      </a:r>
                      <a:r>
                        <a:rPr lang="nl-NL" dirty="0" smtClean="0"/>
                        <a:t> / l)</a:t>
                      </a:r>
                    </a:p>
                    <a:p>
                      <a:endParaRPr lang="nl-NL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l-NL" dirty="0" smtClean="0"/>
                        <a:t>0.70 – 1.90</a:t>
                      </a:r>
                      <a:endParaRPr lang="nl-NL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l-NL" dirty="0" smtClean="0"/>
                        <a:t>0.80 – 3.50</a:t>
                      </a:r>
                      <a:endParaRPr lang="nl-NL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l-NL" dirty="0" smtClean="0"/>
                        <a:t>0.70 – 4.20</a:t>
                      </a:r>
                      <a:endParaRPr lang="nl-NL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l-NL" dirty="0" smtClean="0"/>
                        <a:t>Total </a:t>
                      </a:r>
                      <a:r>
                        <a:rPr lang="nl-NL" dirty="0" err="1" smtClean="0"/>
                        <a:t>number</a:t>
                      </a:r>
                      <a:r>
                        <a:rPr lang="nl-NL" dirty="0" smtClean="0"/>
                        <a:t> of NK </a:t>
                      </a:r>
                      <a:r>
                        <a:rPr lang="nl-NL" dirty="0" err="1" smtClean="0"/>
                        <a:t>cells</a:t>
                      </a:r>
                      <a:r>
                        <a:rPr lang="nl-NL" dirty="0" smtClean="0"/>
                        <a:t> (x 10</a:t>
                      </a:r>
                      <a:r>
                        <a:rPr lang="nl-NL" baseline="30000" dirty="0" smtClean="0"/>
                        <a:t>9</a:t>
                      </a:r>
                      <a:r>
                        <a:rPr lang="nl-NL" dirty="0" smtClean="0"/>
                        <a:t> / l)</a:t>
                      </a:r>
                    </a:p>
                    <a:p>
                      <a:endParaRPr lang="nl-NL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l-NL" dirty="0" smtClean="0"/>
                        <a:t>0.10 – 0.40</a:t>
                      </a:r>
                      <a:endParaRPr lang="nl-NL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l-NL" dirty="0" smtClean="0"/>
                        <a:t>0.07 – 1.20</a:t>
                      </a:r>
                      <a:endParaRPr lang="nl-NL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l-NL" dirty="0" smtClean="0"/>
                        <a:t>0.09 – 0.90</a:t>
                      </a:r>
                      <a:endParaRPr lang="nl-NL" dirty="0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272480" y="260648"/>
            <a:ext cx="73448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 smtClean="0"/>
              <a:t>Appendix </a:t>
            </a:r>
            <a:r>
              <a:rPr lang="nl-NL" dirty="0" err="1"/>
              <a:t>t</a:t>
            </a:r>
            <a:r>
              <a:rPr lang="nl-NL" dirty="0" err="1" smtClean="0"/>
              <a:t>able</a:t>
            </a:r>
            <a:r>
              <a:rPr lang="nl-NL" dirty="0" smtClean="0"/>
              <a:t> 1: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331749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51</TotalTime>
  <Words>118</Words>
  <Application>Microsoft Office PowerPoint</Application>
  <PresentationFormat>A4 Paper (210x297 mm)</PresentationFormat>
  <Paragraphs>2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Erasmus M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.A.S.H. Dalm</dc:creator>
  <cp:lastModifiedBy>Brian  Sung</cp:lastModifiedBy>
  <cp:revision>36</cp:revision>
  <dcterms:created xsi:type="dcterms:W3CDTF">2015-04-28T12:06:07Z</dcterms:created>
  <dcterms:modified xsi:type="dcterms:W3CDTF">2015-11-05T06:54:06Z</dcterms:modified>
</cp:coreProperties>
</file>